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93" r:id="rId2"/>
    <p:sldId id="295" r:id="rId3"/>
    <p:sldId id="297" r:id="rId4"/>
    <p:sldId id="296" r:id="rId5"/>
    <p:sldId id="298" r:id="rId6"/>
    <p:sldId id="270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160" userDrawn="1">
          <p15:clr>
            <a:srgbClr val="A4A3A4"/>
          </p15:clr>
        </p15:guide>
        <p15:guide id="3" orient="horz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36F1EC3-ABAD-4E55-AAE5-1849D600A8B1}" v="5" dt="2023-04-28T21:16:23.16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9" autoAdjust="0"/>
    <p:restoredTop sz="90112" autoAdjust="0"/>
  </p:normalViewPr>
  <p:slideViewPr>
    <p:cSldViewPr snapToGrid="0" showGuides="1">
      <p:cViewPr>
        <p:scale>
          <a:sx n="60" d="100"/>
          <a:sy n="60" d="100"/>
        </p:scale>
        <p:origin x="2392" y="216"/>
      </p:cViewPr>
      <p:guideLst>
        <p:guide pos="2160"/>
        <p:guide orient="horz"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86C17B-5700-4C8F-B749-226EEB6EAE8C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573AE1-84E2-4506-8623-CE2E6A332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525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C573AE1-84E2-4506-8623-CE2E6A33255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8994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C573AE1-84E2-4506-8623-CE2E6A33255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1226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9C26B8-9EF0-4A5A-ADA4-7ED4FF669A5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2483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75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777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680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588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4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388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561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950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462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168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173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CB5CE-F53B-4D42-BF87-E706D112C77B}" type="datetimeFigureOut">
              <a:rPr lang="en-US" smtClean="0"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A74491-2760-461C-8A00-4C3BC42C6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468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C26D391-C449-0F44-F7AE-46AFB5DBD296}"/>
              </a:ext>
            </a:extLst>
          </p:cNvPr>
          <p:cNvSpPr txBox="1"/>
          <p:nvPr/>
        </p:nvSpPr>
        <p:spPr>
          <a:xfrm>
            <a:off x="1543941" y="3648669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qiA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CECB0D3-8D66-D4F8-17C0-BF2E1425BAB4}"/>
              </a:ext>
            </a:extLst>
          </p:cNvPr>
          <p:cNvSpPr txBox="1"/>
          <p:nvPr/>
        </p:nvSpPr>
        <p:spPr>
          <a:xfrm>
            <a:off x="3601408" y="3639118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qiA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E12A8CF2-409C-5198-16DF-810AC9E829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6640"/>
          <a:stretch/>
        </p:blipFill>
        <p:spPr>
          <a:xfrm>
            <a:off x="1515487" y="1119377"/>
            <a:ext cx="1016430" cy="129803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E1831278-19F8-2DF2-26C5-E80BD8E0B6D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7244"/>
          <a:stretch/>
        </p:blipFill>
        <p:spPr>
          <a:xfrm>
            <a:off x="1515487" y="2640992"/>
            <a:ext cx="976692" cy="879213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A397DDC-6557-2AF2-A669-6775C12FD58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478" b="7324"/>
          <a:stretch/>
        </p:blipFill>
        <p:spPr>
          <a:xfrm>
            <a:off x="3470353" y="2438131"/>
            <a:ext cx="1307055" cy="127694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63217175-6B7C-2BDC-CBE3-943927E0B5D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7948"/>
          <a:stretch/>
        </p:blipFill>
        <p:spPr>
          <a:xfrm>
            <a:off x="3429000" y="1133135"/>
            <a:ext cx="1347788" cy="123754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61CE4FA2-5CA9-117F-1940-9BA0A492515C}"/>
              </a:ext>
            </a:extLst>
          </p:cNvPr>
          <p:cNvSpPr txBox="1"/>
          <p:nvPr/>
        </p:nvSpPr>
        <p:spPr>
          <a:xfrm>
            <a:off x="-70275" y="804825"/>
            <a:ext cx="64033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es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qi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homo-oligomeric complex structures</a:t>
            </a:r>
            <a:endParaRPr lang="en-U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63C8C2D-C120-3148-5B6B-76065844B1E1}"/>
              </a:ext>
            </a:extLst>
          </p:cNvPr>
          <p:cNvCxnSpPr/>
          <p:nvPr/>
        </p:nvCxnSpPr>
        <p:spPr>
          <a:xfrm>
            <a:off x="1534319" y="2417414"/>
            <a:ext cx="31615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Arrow: Curved Down 22">
            <a:extLst>
              <a:ext uri="{FF2B5EF4-FFF2-40B4-BE49-F238E27FC236}">
                <a16:creationId xmlns:a16="http://schemas.microsoft.com/office/drawing/2014/main" id="{ACADA114-AEEE-087B-E1B8-E316F3E97B39}"/>
              </a:ext>
            </a:extLst>
          </p:cNvPr>
          <p:cNvSpPr/>
          <p:nvPr/>
        </p:nvSpPr>
        <p:spPr>
          <a:xfrm>
            <a:off x="2806634" y="2319465"/>
            <a:ext cx="440675" cy="265068"/>
          </a:xfrm>
          <a:prstGeom prst="curved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A27DF98-8232-6794-5D29-8D8D9CA4A80B}"/>
              </a:ext>
            </a:extLst>
          </p:cNvPr>
          <p:cNvSpPr txBox="1"/>
          <p:nvPr/>
        </p:nvSpPr>
        <p:spPr>
          <a:xfrm>
            <a:off x="2579547" y="254712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90°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BF14322-5A55-24CF-44B2-51651FD8C172}"/>
              </a:ext>
            </a:extLst>
          </p:cNvPr>
          <p:cNvGrpSpPr/>
          <p:nvPr/>
        </p:nvGrpSpPr>
        <p:grpSpPr>
          <a:xfrm>
            <a:off x="1578733" y="1668455"/>
            <a:ext cx="914400" cy="287567"/>
            <a:chOff x="3554044" y="2835531"/>
            <a:chExt cx="914400" cy="287567"/>
          </a:xfrm>
        </p:grpSpPr>
        <p:sp>
          <p:nvSpPr>
            <p:cNvPr id="13" name="Arrow: Left-Right 12">
              <a:extLst>
                <a:ext uri="{FF2B5EF4-FFF2-40B4-BE49-F238E27FC236}">
                  <a16:creationId xmlns:a16="http://schemas.microsoft.com/office/drawing/2014/main" id="{7E70C1F9-36E9-6D4E-6D79-63E7EEE06B19}"/>
                </a:ext>
              </a:extLst>
            </p:cNvPr>
            <p:cNvSpPr/>
            <p:nvPr/>
          </p:nvSpPr>
          <p:spPr>
            <a:xfrm rot="10800000">
              <a:off x="3935585" y="2835531"/>
              <a:ext cx="135920" cy="45719"/>
            </a:xfrm>
            <a:prstGeom prst="leftRightArrow">
              <a:avLst>
                <a:gd name="adj1" fmla="val 50000"/>
                <a:gd name="adj2" fmla="val 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E003498-4427-7EB2-A4E6-C9FB334838DA}"/>
                </a:ext>
              </a:extLst>
            </p:cNvPr>
            <p:cNvSpPr txBox="1"/>
            <p:nvPr/>
          </p:nvSpPr>
          <p:spPr>
            <a:xfrm>
              <a:off x="3554044" y="2846099"/>
              <a:ext cx="91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 Å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34311D21-1800-9644-D84A-59CD2D57A812}"/>
              </a:ext>
            </a:extLst>
          </p:cNvPr>
          <p:cNvGrpSpPr/>
          <p:nvPr/>
        </p:nvGrpSpPr>
        <p:grpSpPr>
          <a:xfrm>
            <a:off x="2160889" y="2164315"/>
            <a:ext cx="914400" cy="287567"/>
            <a:chOff x="3554044" y="2835531"/>
            <a:chExt cx="914400" cy="287567"/>
          </a:xfrm>
        </p:grpSpPr>
        <p:sp>
          <p:nvSpPr>
            <p:cNvPr id="26" name="Arrow: Left-Right 25">
              <a:extLst>
                <a:ext uri="{FF2B5EF4-FFF2-40B4-BE49-F238E27FC236}">
                  <a16:creationId xmlns:a16="http://schemas.microsoft.com/office/drawing/2014/main" id="{CBD22D2E-29E4-FDB8-2845-B87E14C4AB7C}"/>
                </a:ext>
              </a:extLst>
            </p:cNvPr>
            <p:cNvSpPr/>
            <p:nvPr/>
          </p:nvSpPr>
          <p:spPr>
            <a:xfrm rot="10800000">
              <a:off x="3935585" y="2835531"/>
              <a:ext cx="135920" cy="45719"/>
            </a:xfrm>
            <a:prstGeom prst="leftRightArrow">
              <a:avLst>
                <a:gd name="adj1" fmla="val 50000"/>
                <a:gd name="adj2" fmla="val 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EC38FF4-D762-1C8C-DF63-1EB40BED0EBB}"/>
                </a:ext>
              </a:extLst>
            </p:cNvPr>
            <p:cNvSpPr txBox="1"/>
            <p:nvPr/>
          </p:nvSpPr>
          <p:spPr>
            <a:xfrm>
              <a:off x="3554044" y="2846099"/>
              <a:ext cx="91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 Å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2D42300E-C428-E49C-5FF4-A5F33F55075A}"/>
              </a:ext>
            </a:extLst>
          </p:cNvPr>
          <p:cNvGrpSpPr/>
          <p:nvPr/>
        </p:nvGrpSpPr>
        <p:grpSpPr>
          <a:xfrm>
            <a:off x="4216099" y="2174883"/>
            <a:ext cx="914400" cy="287567"/>
            <a:chOff x="3554044" y="2835531"/>
            <a:chExt cx="914400" cy="287567"/>
          </a:xfrm>
        </p:grpSpPr>
        <p:sp>
          <p:nvSpPr>
            <p:cNvPr id="29" name="Arrow: Left-Right 28">
              <a:extLst>
                <a:ext uri="{FF2B5EF4-FFF2-40B4-BE49-F238E27FC236}">
                  <a16:creationId xmlns:a16="http://schemas.microsoft.com/office/drawing/2014/main" id="{087FE65A-8180-1FD6-80A6-215D350E6276}"/>
                </a:ext>
              </a:extLst>
            </p:cNvPr>
            <p:cNvSpPr/>
            <p:nvPr/>
          </p:nvSpPr>
          <p:spPr>
            <a:xfrm rot="10800000">
              <a:off x="3935585" y="2835531"/>
              <a:ext cx="135920" cy="45719"/>
            </a:xfrm>
            <a:prstGeom prst="leftRightArrow">
              <a:avLst>
                <a:gd name="adj1" fmla="val 50000"/>
                <a:gd name="adj2" fmla="val 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6D25E3E-169A-DA94-63E3-57EE3780218D}"/>
                </a:ext>
              </a:extLst>
            </p:cNvPr>
            <p:cNvSpPr txBox="1"/>
            <p:nvPr/>
          </p:nvSpPr>
          <p:spPr>
            <a:xfrm>
              <a:off x="3554044" y="2846099"/>
              <a:ext cx="91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 Å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AF2100A6-56A8-F85E-604F-19C26E7E6A4E}"/>
              </a:ext>
            </a:extLst>
          </p:cNvPr>
          <p:cNvSpPr txBox="1"/>
          <p:nvPr/>
        </p:nvSpPr>
        <p:spPr>
          <a:xfrm>
            <a:off x="167079" y="8514490"/>
            <a:ext cx="4138862" cy="2961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ts val="1500"/>
              </a:lnSpc>
              <a:spcBef>
                <a:spcPts val="2400"/>
              </a:spcBef>
              <a:spcAft>
                <a:spcPts val="0"/>
              </a:spcAft>
            </a:pPr>
            <a:r>
              <a:rPr lang="fr-FR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sz="2000" dirty="0">
              <a:effectLst/>
              <a:latin typeface="Helvetica-Ligh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67922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5" name="Group 94">
            <a:extLst>
              <a:ext uri="{FF2B5EF4-FFF2-40B4-BE49-F238E27FC236}">
                <a16:creationId xmlns:a16="http://schemas.microsoft.com/office/drawing/2014/main" id="{33049350-93E9-6A82-410B-2DCD44C1FD46}"/>
              </a:ext>
            </a:extLst>
          </p:cNvPr>
          <p:cNvGrpSpPr/>
          <p:nvPr/>
        </p:nvGrpSpPr>
        <p:grpSpPr>
          <a:xfrm>
            <a:off x="203378" y="1105782"/>
            <a:ext cx="1124687" cy="846439"/>
            <a:chOff x="114424" y="6560877"/>
            <a:chExt cx="1124687" cy="846439"/>
          </a:xfrm>
        </p:grpSpPr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83A5B97B-92FF-00D8-21C6-89E1374602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86" t="29629" r="22848" b="24815"/>
            <a:stretch/>
          </p:blipFill>
          <p:spPr>
            <a:xfrm rot="465348">
              <a:off x="114424" y="6560877"/>
              <a:ext cx="1124687" cy="709418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39A8E7F-7379-5FFE-D63F-A96DAC10E35C}"/>
                </a:ext>
              </a:extLst>
            </p:cNvPr>
            <p:cNvSpPr txBox="1"/>
            <p:nvPr/>
          </p:nvSpPr>
          <p:spPr>
            <a:xfrm>
              <a:off x="213246" y="7130317"/>
              <a:ext cx="9270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qiC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4" name="Group 93">
            <a:extLst>
              <a:ext uri="{FF2B5EF4-FFF2-40B4-BE49-F238E27FC236}">
                <a16:creationId xmlns:a16="http://schemas.microsoft.com/office/drawing/2014/main" id="{814573C7-353A-18B9-A857-E9B2C70EF81C}"/>
              </a:ext>
            </a:extLst>
          </p:cNvPr>
          <p:cNvGrpSpPr/>
          <p:nvPr/>
        </p:nvGrpSpPr>
        <p:grpSpPr>
          <a:xfrm>
            <a:off x="2153467" y="1105782"/>
            <a:ext cx="1465782" cy="842382"/>
            <a:chOff x="1302352" y="6539353"/>
            <a:chExt cx="1465782" cy="842382"/>
          </a:xfrm>
        </p:grpSpPr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641CE2C3-61C0-4FAD-E3FF-D270ED6473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95" t="22963" r="13993" b="24445"/>
            <a:stretch/>
          </p:blipFill>
          <p:spPr>
            <a:xfrm>
              <a:off x="1302352" y="6539353"/>
              <a:ext cx="1465782" cy="794061"/>
            </a:xfrm>
            <a:prstGeom prst="rect">
              <a:avLst/>
            </a:prstGeom>
          </p:spPr>
        </p:pic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5A41BAB6-F94D-52BA-5C9D-287A2B76CAE8}"/>
                </a:ext>
              </a:extLst>
            </p:cNvPr>
            <p:cNvSpPr txBox="1"/>
            <p:nvPr/>
          </p:nvSpPr>
          <p:spPr>
            <a:xfrm>
              <a:off x="1564210" y="7104736"/>
              <a:ext cx="9270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qiC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2A208ED8-9D6E-8C6F-8305-2555AF962708}"/>
              </a:ext>
            </a:extLst>
          </p:cNvPr>
          <p:cNvGrpSpPr/>
          <p:nvPr/>
        </p:nvGrpSpPr>
        <p:grpSpPr>
          <a:xfrm>
            <a:off x="4247951" y="1002014"/>
            <a:ext cx="1637370" cy="991240"/>
            <a:chOff x="2748341" y="6402663"/>
            <a:chExt cx="1637370" cy="991240"/>
          </a:xfrm>
        </p:grpSpPr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F81F1F05-B59E-98F2-243E-98D138964A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51" t="23333" r="13993" b="17778"/>
            <a:stretch/>
          </p:blipFill>
          <p:spPr>
            <a:xfrm rot="21480000">
              <a:off x="2748341" y="6402663"/>
              <a:ext cx="1637370" cy="991240"/>
            </a:xfrm>
            <a:prstGeom prst="rect">
              <a:avLst/>
            </a:prstGeom>
          </p:spPr>
        </p:pic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516EE8B4-BA86-242A-D843-FD46735DD205}"/>
                </a:ext>
              </a:extLst>
            </p:cNvPr>
            <p:cNvSpPr txBox="1"/>
            <p:nvPr/>
          </p:nvSpPr>
          <p:spPr>
            <a:xfrm>
              <a:off x="3110070" y="7071814"/>
              <a:ext cx="9270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qiC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2F363E87-0F9C-45BA-24BD-B31A10EDF7E7}"/>
              </a:ext>
            </a:extLst>
          </p:cNvPr>
          <p:cNvGrpSpPr/>
          <p:nvPr/>
        </p:nvGrpSpPr>
        <p:grpSpPr>
          <a:xfrm>
            <a:off x="0" y="2596761"/>
            <a:ext cx="1890978" cy="1727146"/>
            <a:chOff x="3042049" y="8277225"/>
            <a:chExt cx="1890978" cy="1727146"/>
          </a:xfrm>
        </p:grpSpPr>
        <p:pic>
          <p:nvPicPr>
            <p:cNvPr id="67" name="Picture 66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E9B35A96-090C-CB8E-3644-2E26F3EBF8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82" t="6063" r="14969" b="5549"/>
            <a:stretch/>
          </p:blipFill>
          <p:spPr>
            <a:xfrm>
              <a:off x="3042049" y="8277225"/>
              <a:ext cx="1573913" cy="1462339"/>
            </a:xfrm>
            <a:prstGeom prst="rect">
              <a:avLst/>
            </a:prstGeom>
          </p:spPr>
        </p:pic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210D801-B38E-E475-9F4B-B3068391EA4F}"/>
                </a:ext>
              </a:extLst>
            </p:cNvPr>
            <p:cNvSpPr txBox="1"/>
            <p:nvPr/>
          </p:nvSpPr>
          <p:spPr>
            <a:xfrm>
              <a:off x="3344250" y="9727372"/>
              <a:ext cx="9270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qiC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Arrow: Left-Right 70">
              <a:extLst>
                <a:ext uri="{FF2B5EF4-FFF2-40B4-BE49-F238E27FC236}">
                  <a16:creationId xmlns:a16="http://schemas.microsoft.com/office/drawing/2014/main" id="{6F3DE8A3-CC05-84B9-7112-81EF9CB4B12B}"/>
                </a:ext>
              </a:extLst>
            </p:cNvPr>
            <p:cNvSpPr/>
            <p:nvPr/>
          </p:nvSpPr>
          <p:spPr>
            <a:xfrm rot="5400000">
              <a:off x="4294613" y="8937401"/>
              <a:ext cx="602624" cy="45719"/>
            </a:xfrm>
            <a:prstGeom prst="leftRightArrow">
              <a:avLst>
                <a:gd name="adj1" fmla="val 50000"/>
                <a:gd name="adj2" fmla="val 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C20022DC-131F-8DCF-7A24-C806D6D8C72F}"/>
                </a:ext>
              </a:extLst>
            </p:cNvPr>
            <p:cNvSpPr txBox="1"/>
            <p:nvPr/>
          </p:nvSpPr>
          <p:spPr>
            <a:xfrm rot="16200000">
              <a:off x="4331007" y="8841837"/>
              <a:ext cx="9270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0 Å</a:t>
              </a:r>
            </a:p>
          </p:txBody>
        </p: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18D6BAD7-70EE-5A09-7BB7-C9F9695DCF46}"/>
              </a:ext>
            </a:extLst>
          </p:cNvPr>
          <p:cNvGrpSpPr/>
          <p:nvPr/>
        </p:nvGrpSpPr>
        <p:grpSpPr>
          <a:xfrm>
            <a:off x="1696051" y="2356325"/>
            <a:ext cx="2381301" cy="1974999"/>
            <a:chOff x="4930891" y="8145093"/>
            <a:chExt cx="2381301" cy="1974999"/>
          </a:xfrm>
        </p:grpSpPr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0272B520-25B7-C9B4-F2AF-84E81CE4BBE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30891" y="8145093"/>
              <a:ext cx="2342515" cy="1756887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7D2EAF9E-AD2A-CD5C-8E56-3B63DD6A52D8}"/>
                </a:ext>
              </a:extLst>
            </p:cNvPr>
            <p:cNvSpPr txBox="1"/>
            <p:nvPr/>
          </p:nvSpPr>
          <p:spPr>
            <a:xfrm>
              <a:off x="5638807" y="9843093"/>
              <a:ext cx="9270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qiC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Arrow: Left-Right 72">
              <a:extLst>
                <a:ext uri="{FF2B5EF4-FFF2-40B4-BE49-F238E27FC236}">
                  <a16:creationId xmlns:a16="http://schemas.microsoft.com/office/drawing/2014/main" id="{87DDCF0B-5EE0-255F-12B5-9B1F4B092B32}"/>
                </a:ext>
              </a:extLst>
            </p:cNvPr>
            <p:cNvSpPr/>
            <p:nvPr/>
          </p:nvSpPr>
          <p:spPr>
            <a:xfrm rot="5400000">
              <a:off x="6610503" y="8980883"/>
              <a:ext cx="729175" cy="50291"/>
            </a:xfrm>
            <a:prstGeom prst="leftRightArrow">
              <a:avLst>
                <a:gd name="adj1" fmla="val 50000"/>
                <a:gd name="adj2" fmla="val 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71F553F-82DC-8091-44EB-484BAEA26BDA}"/>
                </a:ext>
              </a:extLst>
            </p:cNvPr>
            <p:cNvSpPr txBox="1"/>
            <p:nvPr/>
          </p:nvSpPr>
          <p:spPr>
            <a:xfrm rot="16200000">
              <a:off x="6710172" y="8887605"/>
              <a:ext cx="9270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Å</a:t>
              </a:r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84813551-8AC9-0C82-0208-70D853D1FDA2}"/>
              </a:ext>
            </a:extLst>
          </p:cNvPr>
          <p:cNvGrpSpPr/>
          <p:nvPr/>
        </p:nvGrpSpPr>
        <p:grpSpPr>
          <a:xfrm>
            <a:off x="4043538" y="1977125"/>
            <a:ext cx="2365052" cy="2349965"/>
            <a:chOff x="3821425" y="9604768"/>
            <a:chExt cx="2365052" cy="2349965"/>
          </a:xfrm>
        </p:grpSpPr>
        <p:pic>
          <p:nvPicPr>
            <p:cNvPr id="55" name="Picture 54" descr="Background pattern&#10;&#10;Description automatically generated with medium confidence">
              <a:extLst>
                <a:ext uri="{FF2B5EF4-FFF2-40B4-BE49-F238E27FC236}">
                  <a16:creationId xmlns:a16="http://schemas.microsoft.com/office/drawing/2014/main" id="{0D004A3E-47EC-51EA-AD5E-5504D95131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06" r="14584" b="-1482"/>
            <a:stretch/>
          </p:blipFill>
          <p:spPr>
            <a:xfrm>
              <a:off x="3821425" y="9604768"/>
              <a:ext cx="2046197" cy="2115734"/>
            </a:xfrm>
            <a:prstGeom prst="rect">
              <a:avLst/>
            </a:prstGeom>
          </p:spPr>
        </p:pic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FBE84267-ADB1-2DB0-B477-CA75329A5255}"/>
                </a:ext>
              </a:extLst>
            </p:cNvPr>
            <p:cNvSpPr txBox="1"/>
            <p:nvPr/>
          </p:nvSpPr>
          <p:spPr>
            <a:xfrm>
              <a:off x="4381002" y="11677734"/>
              <a:ext cx="9270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qiC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Arrow: Left-Right 74">
              <a:extLst>
                <a:ext uri="{FF2B5EF4-FFF2-40B4-BE49-F238E27FC236}">
                  <a16:creationId xmlns:a16="http://schemas.microsoft.com/office/drawing/2014/main" id="{83235D93-4D5D-2ADC-1F8E-B5A3C44EAE3F}"/>
                </a:ext>
              </a:extLst>
            </p:cNvPr>
            <p:cNvSpPr/>
            <p:nvPr/>
          </p:nvSpPr>
          <p:spPr>
            <a:xfrm rot="5400000">
              <a:off x="5392175" y="10727030"/>
              <a:ext cx="914400" cy="45719"/>
            </a:xfrm>
            <a:prstGeom prst="leftRightArrow">
              <a:avLst>
                <a:gd name="adj1" fmla="val 50000"/>
                <a:gd name="adj2" fmla="val 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F794C522-BD38-FCEC-FF85-80538821E317}"/>
                </a:ext>
              </a:extLst>
            </p:cNvPr>
            <p:cNvSpPr txBox="1"/>
            <p:nvPr/>
          </p:nvSpPr>
          <p:spPr>
            <a:xfrm rot="16200000">
              <a:off x="5584457" y="10587338"/>
              <a:ext cx="9270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0 Å</a:t>
              </a:r>
            </a:p>
          </p:txBody>
        </p:sp>
      </p:grpSp>
      <p:sp>
        <p:nvSpPr>
          <p:cNvPr id="91" name="TextBox 90">
            <a:extLst>
              <a:ext uri="{FF2B5EF4-FFF2-40B4-BE49-F238E27FC236}">
                <a16:creationId xmlns:a16="http://schemas.microsoft.com/office/drawing/2014/main" id="{3B28E18F-82B0-87A8-C70F-BA2B9D249230}"/>
              </a:ext>
            </a:extLst>
          </p:cNvPr>
          <p:cNvSpPr txBox="1"/>
          <p:nvPr/>
        </p:nvSpPr>
        <p:spPr>
          <a:xfrm>
            <a:off x="0" y="754913"/>
            <a:ext cx="64033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es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q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homo-oligomeric complex structures</a:t>
            </a:r>
            <a:endParaRPr lang="en-U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9A489C2-F3FC-973C-899B-07347BA45865}"/>
              </a:ext>
            </a:extLst>
          </p:cNvPr>
          <p:cNvSpPr txBox="1"/>
          <p:nvPr/>
        </p:nvSpPr>
        <p:spPr>
          <a:xfrm>
            <a:off x="167079" y="8514490"/>
            <a:ext cx="4138862" cy="2961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ts val="1500"/>
              </a:lnSpc>
              <a:spcBef>
                <a:spcPts val="2400"/>
              </a:spcBef>
              <a:spcAft>
                <a:spcPts val="0"/>
              </a:spcAft>
            </a:pPr>
            <a:r>
              <a:rPr lang="fr-FR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en-US" sz="2000" dirty="0">
              <a:effectLst/>
              <a:latin typeface="Helvetica-Ligh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27164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80062045-65C1-D8F5-AD9F-5F3D9FCC645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98" t="4612" r="9136" b="3592"/>
          <a:stretch/>
        </p:blipFill>
        <p:spPr>
          <a:xfrm>
            <a:off x="3729216" y="758553"/>
            <a:ext cx="1808409" cy="217662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5463A9D-2DC7-62E1-6584-65FD6201A73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08" t="5327" r="4164" b="12276"/>
          <a:stretch/>
        </p:blipFill>
        <p:spPr>
          <a:xfrm>
            <a:off x="1201022" y="957847"/>
            <a:ext cx="1892328" cy="180826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43466824-E345-0AE9-0A6F-A42837B64100}"/>
              </a:ext>
            </a:extLst>
          </p:cNvPr>
          <p:cNvSpPr txBox="1"/>
          <p:nvPr/>
        </p:nvSpPr>
        <p:spPr>
          <a:xfrm>
            <a:off x="759637" y="2921429"/>
            <a:ext cx="51075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qiA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PqiB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-13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left) and PqiA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PqiB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-13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right) predictions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ith imbalanced interactions betwee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qi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hain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07E9E85-977F-569F-1106-D460A96233FD}"/>
              </a:ext>
            </a:extLst>
          </p:cNvPr>
          <p:cNvSpPr txBox="1"/>
          <p:nvPr/>
        </p:nvSpPr>
        <p:spPr>
          <a:xfrm>
            <a:off x="167079" y="8514490"/>
            <a:ext cx="4138862" cy="2961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ts val="1500"/>
              </a:lnSpc>
              <a:spcBef>
                <a:spcPts val="2400"/>
              </a:spcBef>
              <a:spcAft>
                <a:spcPts val="0"/>
              </a:spcAft>
            </a:pPr>
            <a:r>
              <a:rPr lang="fr-FR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en-US" sz="2000" dirty="0">
              <a:effectLst/>
              <a:latin typeface="Helvetica-Ligh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28161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C892773-9205-A3C9-9272-31E93EFE3E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61" r="29910"/>
          <a:stretch/>
        </p:blipFill>
        <p:spPr>
          <a:xfrm>
            <a:off x="783469" y="399286"/>
            <a:ext cx="1376319" cy="1792228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0B1046D4-9429-2183-3970-2A21551426AA}"/>
              </a:ext>
            </a:extLst>
          </p:cNvPr>
          <p:cNvGrpSpPr/>
          <p:nvPr/>
        </p:nvGrpSpPr>
        <p:grpSpPr>
          <a:xfrm rot="16200000">
            <a:off x="1908394" y="973372"/>
            <a:ext cx="886491" cy="914400"/>
            <a:chOff x="4547839" y="7100819"/>
            <a:chExt cx="886492" cy="914400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23B0E08-F80C-B0C7-9F42-E46CEBD92360}"/>
                </a:ext>
              </a:extLst>
            </p:cNvPr>
            <p:cNvSpPr txBox="1"/>
            <p:nvPr/>
          </p:nvSpPr>
          <p:spPr>
            <a:xfrm rot="5400000">
              <a:off x="4229139" y="7419519"/>
              <a:ext cx="91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90°</a:t>
              </a: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C5E4A435-7B19-488A-C7FD-EBDE93B6BA86}"/>
                </a:ext>
              </a:extLst>
            </p:cNvPr>
            <p:cNvCxnSpPr/>
            <p:nvPr/>
          </p:nvCxnSpPr>
          <p:spPr>
            <a:xfrm>
              <a:off x="4824839" y="7541914"/>
              <a:ext cx="60949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Arrow: Curved Down 7">
              <a:extLst>
                <a:ext uri="{FF2B5EF4-FFF2-40B4-BE49-F238E27FC236}">
                  <a16:creationId xmlns:a16="http://schemas.microsoft.com/office/drawing/2014/main" id="{EA994BBB-5919-B273-3C11-FBBE7A6DCB3E}"/>
                </a:ext>
              </a:extLst>
            </p:cNvPr>
            <p:cNvSpPr/>
            <p:nvPr/>
          </p:nvSpPr>
          <p:spPr>
            <a:xfrm>
              <a:off x="4970679" y="7403564"/>
              <a:ext cx="339761" cy="308908"/>
            </a:xfrm>
            <a:prstGeom prst="curved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2E248255-05FE-0A30-4FEE-9B9C5F0F4BB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58" r="25961"/>
          <a:stretch/>
        </p:blipFill>
        <p:spPr>
          <a:xfrm>
            <a:off x="2646523" y="383566"/>
            <a:ext cx="1307980" cy="1792228"/>
          </a:xfrm>
          <a:prstGeom prst="rect">
            <a:avLst/>
          </a:prstGeom>
        </p:spPr>
      </p:pic>
      <p:pic>
        <p:nvPicPr>
          <p:cNvPr id="10" name="Picture 9" descr="A picture containing chain&#10;&#10;Description automatically generated">
            <a:extLst>
              <a:ext uri="{FF2B5EF4-FFF2-40B4-BE49-F238E27FC236}">
                <a16:creationId xmlns:a16="http://schemas.microsoft.com/office/drawing/2014/main" id="{CF8F3AE9-D7B0-7195-7F67-2785DD7F82A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41" t="13420" r="25578"/>
          <a:stretch/>
        </p:blipFill>
        <p:spPr>
          <a:xfrm>
            <a:off x="4751029" y="519546"/>
            <a:ext cx="1246043" cy="1551711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F5C0A730-55B6-5DBD-1110-4AF222EE65F9}"/>
              </a:ext>
            </a:extLst>
          </p:cNvPr>
          <p:cNvGrpSpPr/>
          <p:nvPr/>
        </p:nvGrpSpPr>
        <p:grpSpPr>
          <a:xfrm>
            <a:off x="3984037" y="1161229"/>
            <a:ext cx="914400" cy="536604"/>
            <a:chOff x="4705329" y="7403564"/>
            <a:chExt cx="914400" cy="536604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01ACD25-0672-047E-E6B2-690AA4ACD0A2}"/>
                </a:ext>
              </a:extLst>
            </p:cNvPr>
            <p:cNvSpPr txBox="1"/>
            <p:nvPr/>
          </p:nvSpPr>
          <p:spPr>
            <a:xfrm>
              <a:off x="4705329" y="7663169"/>
              <a:ext cx="91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90°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5892986E-BEA5-DDAC-E09F-1EF7AEB6E396}"/>
                </a:ext>
              </a:extLst>
            </p:cNvPr>
            <p:cNvCxnSpPr/>
            <p:nvPr/>
          </p:nvCxnSpPr>
          <p:spPr>
            <a:xfrm>
              <a:off x="4824839" y="7541914"/>
              <a:ext cx="60949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Arrow: Curved Down 13">
              <a:extLst>
                <a:ext uri="{FF2B5EF4-FFF2-40B4-BE49-F238E27FC236}">
                  <a16:creationId xmlns:a16="http://schemas.microsoft.com/office/drawing/2014/main" id="{AB47DF4D-E6A1-AC14-27E3-8AA2B1311859}"/>
                </a:ext>
              </a:extLst>
            </p:cNvPr>
            <p:cNvSpPr/>
            <p:nvPr/>
          </p:nvSpPr>
          <p:spPr>
            <a:xfrm>
              <a:off x="4970679" y="7403564"/>
              <a:ext cx="339761" cy="308908"/>
            </a:xfrm>
            <a:prstGeom prst="curved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12A9146B-1CC6-D571-6B22-3435AAE8DB4B}"/>
              </a:ext>
            </a:extLst>
          </p:cNvPr>
          <p:cNvSpPr txBox="1"/>
          <p:nvPr/>
        </p:nvSpPr>
        <p:spPr>
          <a:xfrm>
            <a:off x="167079" y="8514490"/>
            <a:ext cx="4138862" cy="2961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ts val="1500"/>
              </a:lnSpc>
              <a:spcBef>
                <a:spcPts val="2400"/>
              </a:spcBef>
              <a:spcAft>
                <a:spcPts val="0"/>
              </a:spcAft>
            </a:pPr>
            <a:r>
              <a:rPr lang="fr-FR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en-US" sz="2000" dirty="0">
              <a:effectLst/>
              <a:latin typeface="Helvetica-Ligh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34151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plant&#10;&#10;Description automatically generated">
            <a:extLst>
              <a:ext uri="{FF2B5EF4-FFF2-40B4-BE49-F238E27FC236}">
                <a16:creationId xmlns:a16="http://schemas.microsoft.com/office/drawing/2014/main" id="{29A3A889-DE58-79D2-17D8-99E14F68C7A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84" t="18334" r="7500" b="23333"/>
          <a:stretch/>
        </p:blipFill>
        <p:spPr>
          <a:xfrm>
            <a:off x="972859" y="725082"/>
            <a:ext cx="2527301" cy="1778000"/>
          </a:xfrm>
          <a:prstGeom prst="rect">
            <a:avLst/>
          </a:prstGeom>
        </p:spPr>
      </p:pic>
      <p:pic>
        <p:nvPicPr>
          <p:cNvPr id="5" name="Picture 4" descr="A picture containing plant&#10;&#10;Description automatically generated">
            <a:extLst>
              <a:ext uri="{FF2B5EF4-FFF2-40B4-BE49-F238E27FC236}">
                <a16:creationId xmlns:a16="http://schemas.microsoft.com/office/drawing/2014/main" id="{805FBF49-62B7-939C-3D1C-625F1019032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093"/>
          <a:stretch/>
        </p:blipFill>
        <p:spPr>
          <a:xfrm>
            <a:off x="3429000" y="170121"/>
            <a:ext cx="3048006" cy="267940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836D945-E21A-34E7-D51A-E5C545D6E5F9}"/>
              </a:ext>
            </a:extLst>
          </p:cNvPr>
          <p:cNvSpPr txBox="1"/>
          <p:nvPr/>
        </p:nvSpPr>
        <p:spPr>
          <a:xfrm>
            <a:off x="167079" y="8514490"/>
            <a:ext cx="4138862" cy="2961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ts val="1500"/>
              </a:lnSpc>
              <a:spcBef>
                <a:spcPts val="2400"/>
              </a:spcBef>
              <a:spcAft>
                <a:spcPts val="0"/>
              </a:spcAft>
            </a:pPr>
            <a:r>
              <a:rPr lang="fr-FR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en-US" sz="2000" dirty="0">
              <a:effectLst/>
              <a:latin typeface="Helvetica-Ligh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62072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 descr="A picture containing bouquet, flower, plant, porcelain&#10;&#10;Description automatically generated">
            <a:extLst>
              <a:ext uri="{FF2B5EF4-FFF2-40B4-BE49-F238E27FC236}">
                <a16:creationId xmlns:a16="http://schemas.microsoft.com/office/drawing/2014/main" id="{017FCEE1-2F02-15B0-BF89-574E08296B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68"/>
          <a:stretch/>
        </p:blipFill>
        <p:spPr>
          <a:xfrm>
            <a:off x="3559811" y="2135050"/>
            <a:ext cx="1539285" cy="1462552"/>
          </a:xfrm>
          <a:prstGeom prst="rect">
            <a:avLst/>
          </a:prstGeom>
        </p:spPr>
      </p:pic>
      <p:pic>
        <p:nvPicPr>
          <p:cNvPr id="12" name="Picture 11" descr="A close-up of some earrings&#10;&#10;Description automatically generated with medium confidence">
            <a:extLst>
              <a:ext uri="{FF2B5EF4-FFF2-40B4-BE49-F238E27FC236}">
                <a16:creationId xmlns:a16="http://schemas.microsoft.com/office/drawing/2014/main" id="{4AEB5CFB-D0BF-2A20-CE50-40B8D5760CD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14" r="12838"/>
          <a:stretch/>
        </p:blipFill>
        <p:spPr>
          <a:xfrm>
            <a:off x="1872965" y="590043"/>
            <a:ext cx="1484588" cy="1527051"/>
          </a:xfrm>
          <a:prstGeom prst="rect">
            <a:avLst/>
          </a:prstGeom>
        </p:spPr>
      </p:pic>
      <p:pic>
        <p:nvPicPr>
          <p:cNvPr id="16" name="Picture 15" descr="A close-up of some earrings&#10;&#10;Description automatically generated with low confidence">
            <a:extLst>
              <a:ext uri="{FF2B5EF4-FFF2-40B4-BE49-F238E27FC236}">
                <a16:creationId xmlns:a16="http://schemas.microsoft.com/office/drawing/2014/main" id="{DAC8287B-EA0F-F217-5EC6-D253FA5C530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39" r="11371"/>
          <a:stretch/>
        </p:blipFill>
        <p:spPr>
          <a:xfrm>
            <a:off x="3654333" y="552895"/>
            <a:ext cx="1402695" cy="1527051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D386C6B3-EDC5-1921-CC1C-87CB257282F1}"/>
              </a:ext>
            </a:extLst>
          </p:cNvPr>
          <p:cNvSpPr txBox="1"/>
          <p:nvPr/>
        </p:nvSpPr>
        <p:spPr>
          <a:xfrm>
            <a:off x="1719427" y="3633423"/>
            <a:ext cx="199675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best LetA</a:t>
            </a:r>
            <a:r>
              <a:rPr lang="en-US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:LetB</a:t>
            </a:r>
            <a:r>
              <a:rPr lang="en-US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1-137</a:t>
            </a:r>
          </a:p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F2Complex predictio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7F6F034-6F3C-F5CF-F734-91B9E50A2E57}"/>
              </a:ext>
            </a:extLst>
          </p:cNvPr>
          <p:cNvSpPr txBox="1"/>
          <p:nvPr/>
        </p:nvSpPr>
        <p:spPr>
          <a:xfrm>
            <a:off x="3355699" y="3632289"/>
            <a:ext cx="199675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best LetA</a:t>
            </a:r>
            <a:r>
              <a:rPr lang="en-US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:LetB</a:t>
            </a:r>
            <a:r>
              <a:rPr lang="en-US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1-137</a:t>
            </a:r>
          </a:p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F2Complex prediction</a:t>
            </a:r>
          </a:p>
        </p:txBody>
      </p:sp>
      <p:pic>
        <p:nvPicPr>
          <p:cNvPr id="31" name="Picture 30" descr="A picture containing plant, outdoor object, aerie&#10;&#10;Description automatically generated">
            <a:extLst>
              <a:ext uri="{FF2B5EF4-FFF2-40B4-BE49-F238E27FC236}">
                <a16:creationId xmlns:a16="http://schemas.microsoft.com/office/drawing/2014/main" id="{ED7BA094-6491-D6FC-78D2-6194861CEEE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27" t="11543" r="14135" b="23129"/>
          <a:stretch/>
        </p:blipFill>
        <p:spPr>
          <a:xfrm>
            <a:off x="1719426" y="2254253"/>
            <a:ext cx="1726868" cy="1342859"/>
          </a:xfrm>
          <a:prstGeom prst="rect">
            <a:avLst/>
          </a:prstGeom>
        </p:spPr>
      </p:pic>
      <p:grpSp>
        <p:nvGrpSpPr>
          <p:cNvPr id="40" name="Group 39">
            <a:extLst>
              <a:ext uri="{FF2B5EF4-FFF2-40B4-BE49-F238E27FC236}">
                <a16:creationId xmlns:a16="http://schemas.microsoft.com/office/drawing/2014/main" id="{59142F14-1F88-0310-9CB4-0D22FABD6878}"/>
              </a:ext>
            </a:extLst>
          </p:cNvPr>
          <p:cNvGrpSpPr/>
          <p:nvPr/>
        </p:nvGrpSpPr>
        <p:grpSpPr>
          <a:xfrm>
            <a:off x="1988188" y="1996340"/>
            <a:ext cx="3070434" cy="425536"/>
            <a:chOff x="3133421" y="4126160"/>
            <a:chExt cx="4093912" cy="567381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EF5B782-BF07-CABA-3CED-F9421F067B58}"/>
                </a:ext>
              </a:extLst>
            </p:cNvPr>
            <p:cNvSpPr txBox="1"/>
            <p:nvPr/>
          </p:nvSpPr>
          <p:spPr>
            <a:xfrm>
              <a:off x="4748448" y="4385765"/>
              <a:ext cx="914400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90°</a:t>
              </a: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BFC45A1D-E054-C92E-52DE-ACEB57CB2108}"/>
                </a:ext>
              </a:extLst>
            </p:cNvPr>
            <p:cNvCxnSpPr/>
            <p:nvPr/>
          </p:nvCxnSpPr>
          <p:spPr>
            <a:xfrm>
              <a:off x="3133421" y="4264510"/>
              <a:ext cx="409391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Arrow: Curved Down 42">
              <a:extLst>
                <a:ext uri="{FF2B5EF4-FFF2-40B4-BE49-F238E27FC236}">
                  <a16:creationId xmlns:a16="http://schemas.microsoft.com/office/drawing/2014/main" id="{13590E2C-7C20-E00B-1BA0-C003239C000E}"/>
                </a:ext>
              </a:extLst>
            </p:cNvPr>
            <p:cNvSpPr/>
            <p:nvPr/>
          </p:nvSpPr>
          <p:spPr>
            <a:xfrm>
              <a:off x="5059517" y="4126160"/>
              <a:ext cx="274320" cy="274320"/>
            </a:xfrm>
            <a:prstGeom prst="curved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solidFill>
                  <a:schemeClr val="tx1"/>
                </a:solidFill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4A08655-4231-5FBB-24F5-878E44863E8D}"/>
              </a:ext>
            </a:extLst>
          </p:cNvPr>
          <p:cNvSpPr txBox="1"/>
          <p:nvPr/>
        </p:nvSpPr>
        <p:spPr>
          <a:xfrm>
            <a:off x="167079" y="8514490"/>
            <a:ext cx="4138862" cy="2961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ts val="1500"/>
              </a:lnSpc>
              <a:spcBef>
                <a:spcPts val="2400"/>
              </a:spcBef>
              <a:spcAft>
                <a:spcPts val="0"/>
              </a:spcAft>
            </a:pPr>
            <a:r>
              <a:rPr lang="fr-FR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en-US" sz="2000" dirty="0">
              <a:effectLst/>
              <a:latin typeface="Helvetica-Ligh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66880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885</TotalTime>
  <Words>85</Words>
  <Application>Microsoft Office PowerPoint</Application>
  <PresentationFormat>On-screen Show (4:3)</PresentationFormat>
  <Paragraphs>35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Helvetica-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Donnell, Robert T</dc:creator>
  <cp:lastModifiedBy>Adrian Elcock</cp:lastModifiedBy>
  <cp:revision>14</cp:revision>
  <dcterms:created xsi:type="dcterms:W3CDTF">2023-04-21T20:17:54Z</dcterms:created>
  <dcterms:modified xsi:type="dcterms:W3CDTF">2023-04-28T21:20:36Z</dcterms:modified>
</cp:coreProperties>
</file>